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100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sv-SE" altLang="zh-CN" smtClean="0"/>
              <a:t>Click to edit Master subtitle style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59791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69404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25471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0148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1625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009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3456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9506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6016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5978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0224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314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DS-PAGE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9934" y="1103357"/>
            <a:ext cx="2476500" cy="38481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21112" y="4982450"/>
            <a:ext cx="633289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/>
              <a:t>Figure S1. </a:t>
            </a:r>
            <a:r>
              <a:rPr kumimoji="1" lang="en-US" altLang="zh-CN" dirty="0" smtClean="0"/>
              <a:t>Original full length </a:t>
            </a:r>
            <a:r>
              <a:rPr kumimoji="1" lang="en-US" altLang="zh-CN" dirty="0" smtClean="0"/>
              <a:t>image of SDS-PAGE analysis shown in Figure 2A. The SDS-gel was stained with Page Blue protein staining solution (</a:t>
            </a:r>
            <a:r>
              <a:rPr kumimoji="1" lang="en-US" altLang="zh-CN" dirty="0"/>
              <a:t>T</a:t>
            </a:r>
            <a:r>
              <a:rPr kumimoji="1" lang="en-US" altLang="zh-CN" dirty="0" smtClean="0"/>
              <a:t>hermo </a:t>
            </a:r>
            <a:r>
              <a:rPr kumimoji="1" lang="en-US" altLang="zh-CN" dirty="0"/>
              <a:t>S</a:t>
            </a:r>
            <a:r>
              <a:rPr kumimoji="1" lang="en-US" altLang="zh-CN" dirty="0" smtClean="0"/>
              <a:t>cientific) and distained with water. The wet gel was scanned directly. Half of the gel image is shown here because the other half is not relevant.   </a:t>
            </a:r>
            <a:endParaRPr kumimoji="1"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616881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57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-presentation</vt:lpstr>
    </vt:vector>
  </TitlesOfParts>
  <Company>S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ya Wang</dc:creator>
  <cp:lastModifiedBy>Liya Wang</cp:lastModifiedBy>
  <cp:revision>7</cp:revision>
  <dcterms:created xsi:type="dcterms:W3CDTF">2021-11-12T12:09:54Z</dcterms:created>
  <dcterms:modified xsi:type="dcterms:W3CDTF">2021-11-12T13:19:31Z</dcterms:modified>
</cp:coreProperties>
</file>